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6858000" cy="9906000" type="A4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ittlere Formatvorlag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0736" autoAdjust="0"/>
  </p:normalViewPr>
  <p:slideViewPr>
    <p:cSldViewPr>
      <p:cViewPr>
        <p:scale>
          <a:sx n="100" d="100"/>
          <a:sy n="100" d="100"/>
        </p:scale>
        <p:origin x="-2892" y="-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1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/>
          <a:lstStyle>
            <a:lvl1pPr algn="r">
              <a:defRPr sz="1300"/>
            </a:lvl1pPr>
          </a:lstStyle>
          <a:p>
            <a:fld id="{AFF549EC-2D11-46A6-B0A7-ED0A85A81DE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6125"/>
            <a:ext cx="2574925" cy="37226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71" tIns="47786" rIns="95571" bIns="47786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5571" tIns="47786" rIns="95571" bIns="47786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33107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 anchor="b"/>
          <a:lstStyle>
            <a:lvl1pPr algn="r">
              <a:defRPr sz="1300"/>
            </a:lvl1pPr>
          </a:lstStyle>
          <a:p>
            <a:fld id="{5D710603-2D3E-4786-9A44-2160958960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006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710603-2D3E-4786-9A44-2160958960B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6293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963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333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310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574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271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94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064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568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062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702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833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899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5733286"/>
              </p:ext>
            </p:extLst>
          </p:nvPr>
        </p:nvGraphicFramePr>
        <p:xfrm>
          <a:off x="1808634" y="1250901"/>
          <a:ext cx="3006080" cy="914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96347"/>
                <a:gridCol w="1609733"/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arson´s</a:t>
                      </a:r>
                      <a:r>
                        <a:rPr lang="de-DE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²</a:t>
                      </a:r>
                      <a:endParaRPr 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  <a:endParaRPr lang="en-US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de-DE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en-US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US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3" name="Rechteck 2"/>
          <p:cNvSpPr/>
          <p:nvPr/>
        </p:nvSpPr>
        <p:spPr>
          <a:xfrm>
            <a:off x="449610" y="725141"/>
            <a:ext cx="60212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Table 2: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arson´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duct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moment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annon´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iversit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dex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sexual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tercours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onth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dictor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8528461"/>
      </p:ext>
    </p:extLst>
  </p:cSld>
  <p:clrMapOvr>
    <a:masterClrMapping/>
  </p:clrMapOvr>
</p:sld>
</file>

<file path=ppt/theme/theme1.xml><?xml version="1.0" encoding="utf-8"?>
<a:theme xmlns:a="http://schemas.openxmlformats.org/drawingml/2006/main" name="Graspeuntner et al_suppl. figures_SG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Graspeuntner et al_suppl. figures_SG</Template>
  <TotalTime>0</TotalTime>
  <Words>29</Words>
  <Application>Microsoft Office PowerPoint</Application>
  <PresentationFormat>A4-Papier (210x297 mm)</PresentationFormat>
  <Paragraphs>6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Graspeuntner et al_suppl. figures_SG</vt:lpstr>
      <vt:lpstr>PowerPoint-Präsentation</vt:lpstr>
    </vt:vector>
  </TitlesOfParts>
  <Company>ITS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Bi, AGRupp</dc:creator>
  <cp:lastModifiedBy>MiBi, AGRupp</cp:lastModifiedBy>
  <cp:revision>7</cp:revision>
  <cp:lastPrinted>2016-02-13T11:55:58Z</cp:lastPrinted>
  <dcterms:created xsi:type="dcterms:W3CDTF">2016-07-21T14:01:48Z</dcterms:created>
  <dcterms:modified xsi:type="dcterms:W3CDTF">2017-08-11T12:10:33Z</dcterms:modified>
</cp:coreProperties>
</file>